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0" d="100"/>
          <a:sy n="60" d="100"/>
        </p:scale>
        <p:origin x="88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1982A9-4889-368C-AD0B-A2DF69AA380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FFD7985-3E21-EDCB-E5ED-4470E8C18A8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BCCD57-97BC-0BAF-528E-B9FC60158F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6ABA2-BAF7-4FA9-B1DF-7C9B75674FFD}" type="datetimeFigureOut">
              <a:rPr lang="en-US" smtClean="0"/>
              <a:t>2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CF4571-9868-89CC-9632-5AFA6F0BCA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761C57-06AB-52D3-0801-E990F5C4D1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A1F36-E58D-4C4D-B362-2992243A5A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55569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96AFC8-21CC-CDFB-EC3A-B82D1EB6FF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DAEC57B-7B4F-9AA9-A34C-93CDC024DFA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AF4ADE-6A4D-BCA0-3C38-0B6EF55082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6ABA2-BAF7-4FA9-B1DF-7C9B75674FFD}" type="datetimeFigureOut">
              <a:rPr lang="en-US" smtClean="0"/>
              <a:t>2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42BE5A-4EAD-B9D8-B28D-E9D7DD6CF7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7E583A-9939-A10E-7D7E-4454662A75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A1F36-E58D-4C4D-B362-2992243A5A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57741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1C1FA4A-E747-433E-83B7-1DF02F1A36E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75EA193-A1C9-AA88-A41E-4C68BA512F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4C1254-31C5-C2A4-6C24-F1D801D8AC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6ABA2-BAF7-4FA9-B1DF-7C9B75674FFD}" type="datetimeFigureOut">
              <a:rPr lang="en-US" smtClean="0"/>
              <a:t>2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B28FBF-8B7A-2CFB-580B-087E2AF373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47FA27-1A4F-9EB4-1F80-591F60425E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A1F36-E58D-4C4D-B362-2992243A5A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47386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878811-DEC1-187D-34C2-6553475624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A3E5732-17DA-F8F0-93C9-840F3CB57D5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C22AE1-479D-1B01-5B40-F00372D835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6ABA2-BAF7-4FA9-B1DF-7C9B75674FFD}" type="datetimeFigureOut">
              <a:rPr lang="en-US" smtClean="0"/>
              <a:t>2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86CB20-61D4-F7F6-6B48-9E4C108CA7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82F51F-479A-C2D7-49D7-B088530626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A1F36-E58D-4C4D-B362-2992243A5A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13340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9F653E-18AC-CC64-97FB-7715598672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93D737F-0D25-CDFC-E3AC-2EC97B5F37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939A51-33EC-98CE-9EF2-DE64173546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6ABA2-BAF7-4FA9-B1DF-7C9B75674FFD}" type="datetimeFigureOut">
              <a:rPr lang="en-US" smtClean="0"/>
              <a:t>2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645071-5CF9-58B0-4BF3-846E006C6B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C6573A-A941-0881-A560-9DBA78DB44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A1F36-E58D-4C4D-B362-2992243A5A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9301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45F361-CB6F-24CD-E22E-A8A128365F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D52BB95-BF77-BEFF-BE14-8164106901C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8B9BF9C-3567-C007-0306-0B9F4470146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2D66C76-C3F9-BD25-9995-0168B061AD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6ABA2-BAF7-4FA9-B1DF-7C9B75674FFD}" type="datetimeFigureOut">
              <a:rPr lang="en-US" smtClean="0"/>
              <a:t>2/2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40D6D0-CC9F-7EB9-B822-11B8C8AFA9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537E8DF-0342-DE5F-450B-BFA81E814E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A1F36-E58D-4C4D-B362-2992243A5A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93026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A34FD0-C44F-16F1-B1EF-ACED90E3E4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AF60FC6-6692-BF63-E6C4-FE99882201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F424D95-7626-2DFE-E45B-9E428F83E5E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BA67CF8-5A8F-D6F4-500B-2A15D838256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9174CE1-1D4E-D9C4-00F8-4AF0616AF2A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4E44E92-A11B-A75C-26A9-955E101294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6ABA2-BAF7-4FA9-B1DF-7C9B75674FFD}" type="datetimeFigureOut">
              <a:rPr lang="en-US" smtClean="0"/>
              <a:t>2/22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1667DE0-31EF-07A1-AE90-DA02D9F4A4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60A0A4A-D2E9-D989-054E-98E7F8016A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A1F36-E58D-4C4D-B362-2992243A5A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18148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367667-C72E-1566-15D9-962A931A13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18F27DA-003C-DA76-AE43-0A68208F44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6ABA2-BAF7-4FA9-B1DF-7C9B75674FFD}" type="datetimeFigureOut">
              <a:rPr lang="en-US" smtClean="0"/>
              <a:t>2/22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E8D7513-828F-B3DC-6D6B-55FB9183AE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C99B036-E45C-FE6C-8782-943D5EDF38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A1F36-E58D-4C4D-B362-2992243A5A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3474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F5C62BB-1837-B848-F8A2-D40C02B696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6ABA2-BAF7-4FA9-B1DF-7C9B75674FFD}" type="datetimeFigureOut">
              <a:rPr lang="en-US" smtClean="0"/>
              <a:t>2/22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6A778BB-E4E5-62EF-92E5-35773B877B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B1D717E-3FB7-A793-5CC7-E7B638F32E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A1F36-E58D-4C4D-B362-2992243A5A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76335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E4E57D-63A8-55F9-9145-66E697B21A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37D48F7-BC73-8339-9D2C-7FD8772301A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4246DFA-C101-E998-7855-9C128277FC6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89B823D-3BE0-3E08-2A71-CE6E035841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6ABA2-BAF7-4FA9-B1DF-7C9B75674FFD}" type="datetimeFigureOut">
              <a:rPr lang="en-US" smtClean="0"/>
              <a:t>2/2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C3DCDC7-0C48-FB1C-141B-61B7F12BC2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854EC9F-6043-2554-9E2A-B068E316FC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A1F36-E58D-4C4D-B362-2992243A5A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45844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CAD0AE-2484-B419-2C24-07FC76AD9F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FB16F3F-2960-FE47-0460-16F351DAB5F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10F1550-C376-3D67-00EF-EBBB2E629A7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040FF6C-A679-E092-1A98-8EE3468F7C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6ABA2-BAF7-4FA9-B1DF-7C9B75674FFD}" type="datetimeFigureOut">
              <a:rPr lang="en-US" smtClean="0"/>
              <a:t>2/2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04F8DF-9B08-3AA5-20B6-7EDDAD67E9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91BC75C-6066-71FC-6DD4-C082050BD1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A1F36-E58D-4C4D-B362-2992243A5A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32597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BE3DF73-5AAA-BCFE-6BF8-30B59D60A0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67DF3C2-7301-0B49-AC48-A39AFAF257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C88584-40B5-463E-8E2E-6CD70DA30FE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D26ABA2-BAF7-4FA9-B1DF-7C9B75674FFD}" type="datetimeFigureOut">
              <a:rPr lang="en-US" smtClean="0"/>
              <a:t>2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4C3049-DD22-32DD-4ABF-6006BA1D098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B09352-6AD1-60D9-EA82-57481287776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B0A1F36-E58D-4C4D-B362-2992243A5A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01215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463681" y="3057012"/>
            <a:ext cx="967977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2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. Summary of RNA-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results showing increased IL-24 expression following TXNIP overexpression in HCC-1954 cells and following UNC0642 treatment in MDA-MB-231 cells. In contrast, IL-24 expression is downregulated following TXNIP knockdown in MDA-MB-231 cells.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75191" y="885628"/>
            <a:ext cx="696847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1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. List of primer sequences used in PCR analysis of the expression of TXNIP, IL-24, and TBP.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0CE5777A-9816-BE1C-B317-4C8C2C60ED4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32475716"/>
              </p:ext>
            </p:extLst>
          </p:nvPr>
        </p:nvGraphicFramePr>
        <p:xfrm>
          <a:off x="463681" y="1553706"/>
          <a:ext cx="6777091" cy="835228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513427">
                  <a:extLst>
                    <a:ext uri="{9D8B030D-6E8A-4147-A177-3AD203B41FA5}">
                      <a16:colId xmlns:a16="http://schemas.microsoft.com/office/drawing/2014/main" val="3466723445"/>
                    </a:ext>
                  </a:extLst>
                </a:gridCol>
                <a:gridCol w="651549">
                  <a:extLst>
                    <a:ext uri="{9D8B030D-6E8A-4147-A177-3AD203B41FA5}">
                      <a16:colId xmlns:a16="http://schemas.microsoft.com/office/drawing/2014/main" val="1647374303"/>
                    </a:ext>
                  </a:extLst>
                </a:gridCol>
                <a:gridCol w="2699675">
                  <a:extLst>
                    <a:ext uri="{9D8B030D-6E8A-4147-A177-3AD203B41FA5}">
                      <a16:colId xmlns:a16="http://schemas.microsoft.com/office/drawing/2014/main" val="3783615489"/>
                    </a:ext>
                  </a:extLst>
                </a:gridCol>
                <a:gridCol w="2912440">
                  <a:extLst>
                    <a:ext uri="{9D8B030D-6E8A-4147-A177-3AD203B41FA5}">
                      <a16:colId xmlns:a16="http://schemas.microsoft.com/office/drawing/2014/main" val="2513328946"/>
                    </a:ext>
                  </a:extLst>
                </a:gridCol>
              </a:tblGrid>
              <a:tr h="20880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.no</a:t>
                      </a:r>
                      <a:endParaRPr lang="en-US" sz="1100" b="1" kern="100" dirty="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  <a:endParaRPr lang="en-US" sz="1100" b="1" kern="100" dirty="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 Primer</a:t>
                      </a:r>
                      <a:endParaRPr lang="en-US" sz="1100" b="1" kern="100" dirty="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 Primer</a:t>
                      </a:r>
                      <a:endParaRPr lang="en-US" sz="1100" b="1" kern="100" dirty="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145586760"/>
                  </a:ext>
                </a:extLst>
              </a:tr>
              <a:tr h="20880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100" kern="100" dirty="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XNIP</a:t>
                      </a:r>
                      <a:endParaRPr lang="en-US" sz="1100" kern="100" dirty="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TGGGTGTGTAGACTACTGGG</a:t>
                      </a:r>
                      <a:endParaRPr lang="en-US" sz="1100" kern="100" dirty="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CATCCACCAGATCCACTACT</a:t>
                      </a:r>
                      <a:endParaRPr lang="en-US" sz="1100" kern="1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428684301"/>
                  </a:ext>
                </a:extLst>
              </a:tr>
              <a:tr h="20880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</a:t>
                      </a:r>
                      <a:endParaRPr lang="en-US" sz="1100" kern="1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24</a:t>
                      </a:r>
                      <a:endParaRPr lang="en-US" sz="1100" kern="1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CACAGGCGGTTTCTGCTAT</a:t>
                      </a:r>
                      <a:endParaRPr lang="en-US" sz="1100" kern="100" dirty="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CAACTGTTTGAATGCTCTCCC</a:t>
                      </a:r>
                      <a:endParaRPr lang="en-US" sz="1100" kern="100" dirty="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797017459"/>
                  </a:ext>
                </a:extLst>
              </a:tr>
              <a:tr h="20880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</a:t>
                      </a:r>
                      <a:endParaRPr lang="en-US" sz="1100" kern="1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BP</a:t>
                      </a:r>
                      <a:endParaRPr lang="en-US" sz="1100" kern="1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TCGTGGTCACACTTGTTGAG</a:t>
                      </a:r>
                      <a:endParaRPr lang="en-US" sz="1100" kern="100" dirty="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ATCCTCTGAGACCGTTTT</a:t>
                      </a:r>
                      <a:endParaRPr lang="en-US" sz="1100" kern="100" dirty="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938402069"/>
                  </a:ext>
                </a:extLst>
              </a:tr>
            </a:tbl>
          </a:graphicData>
        </a:graphic>
      </p:graphicFrame>
      <p:graphicFrame>
        <p:nvGraphicFramePr>
          <p:cNvPr id="62" name="Table 61">
            <a:extLst>
              <a:ext uri="{FF2B5EF4-FFF2-40B4-BE49-F238E27FC236}">
                <a16:creationId xmlns:a16="http://schemas.microsoft.com/office/drawing/2014/main" id="{161CCEDE-05FA-55D4-3034-8AC01D5DA69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55390883"/>
              </p:ext>
            </p:extLst>
          </p:nvPr>
        </p:nvGraphicFramePr>
        <p:xfrm>
          <a:off x="558944" y="3879826"/>
          <a:ext cx="9584515" cy="158530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417680">
                  <a:extLst>
                    <a:ext uri="{9D8B030D-6E8A-4147-A177-3AD203B41FA5}">
                      <a16:colId xmlns:a16="http://schemas.microsoft.com/office/drawing/2014/main" val="329796655"/>
                    </a:ext>
                  </a:extLst>
                </a:gridCol>
                <a:gridCol w="675989">
                  <a:extLst>
                    <a:ext uri="{9D8B030D-6E8A-4147-A177-3AD203B41FA5}">
                      <a16:colId xmlns:a16="http://schemas.microsoft.com/office/drawing/2014/main" val="3828252611"/>
                    </a:ext>
                  </a:extLst>
                </a:gridCol>
                <a:gridCol w="749806">
                  <a:extLst>
                    <a:ext uri="{9D8B030D-6E8A-4147-A177-3AD203B41FA5}">
                      <a16:colId xmlns:a16="http://schemas.microsoft.com/office/drawing/2014/main" val="925936999"/>
                    </a:ext>
                  </a:extLst>
                </a:gridCol>
                <a:gridCol w="733646">
                  <a:extLst>
                    <a:ext uri="{9D8B030D-6E8A-4147-A177-3AD203B41FA5}">
                      <a16:colId xmlns:a16="http://schemas.microsoft.com/office/drawing/2014/main" val="2921693781"/>
                    </a:ext>
                  </a:extLst>
                </a:gridCol>
                <a:gridCol w="669851">
                  <a:extLst>
                    <a:ext uri="{9D8B030D-6E8A-4147-A177-3AD203B41FA5}">
                      <a16:colId xmlns:a16="http://schemas.microsoft.com/office/drawing/2014/main" val="973483316"/>
                    </a:ext>
                  </a:extLst>
                </a:gridCol>
                <a:gridCol w="659219">
                  <a:extLst>
                    <a:ext uri="{9D8B030D-6E8A-4147-A177-3AD203B41FA5}">
                      <a16:colId xmlns:a16="http://schemas.microsoft.com/office/drawing/2014/main" val="129017984"/>
                    </a:ext>
                  </a:extLst>
                </a:gridCol>
                <a:gridCol w="712381">
                  <a:extLst>
                    <a:ext uri="{9D8B030D-6E8A-4147-A177-3AD203B41FA5}">
                      <a16:colId xmlns:a16="http://schemas.microsoft.com/office/drawing/2014/main" val="4221115861"/>
                    </a:ext>
                  </a:extLst>
                </a:gridCol>
                <a:gridCol w="926737">
                  <a:extLst>
                    <a:ext uri="{9D8B030D-6E8A-4147-A177-3AD203B41FA5}">
                      <a16:colId xmlns:a16="http://schemas.microsoft.com/office/drawing/2014/main" val="1552002558"/>
                    </a:ext>
                  </a:extLst>
                </a:gridCol>
                <a:gridCol w="956278">
                  <a:extLst>
                    <a:ext uri="{9D8B030D-6E8A-4147-A177-3AD203B41FA5}">
                      <a16:colId xmlns:a16="http://schemas.microsoft.com/office/drawing/2014/main" val="995385175"/>
                    </a:ext>
                  </a:extLst>
                </a:gridCol>
                <a:gridCol w="1011237">
                  <a:extLst>
                    <a:ext uri="{9D8B030D-6E8A-4147-A177-3AD203B41FA5}">
                      <a16:colId xmlns:a16="http://schemas.microsoft.com/office/drawing/2014/main" val="3581787705"/>
                    </a:ext>
                  </a:extLst>
                </a:gridCol>
                <a:gridCol w="1071691">
                  <a:extLst>
                    <a:ext uri="{9D8B030D-6E8A-4147-A177-3AD203B41FA5}">
                      <a16:colId xmlns:a16="http://schemas.microsoft.com/office/drawing/2014/main" val="3825841770"/>
                    </a:ext>
                  </a:extLst>
                </a:gridCol>
              </a:tblGrid>
              <a:tr h="385049">
                <a:tc>
                  <a:txBody>
                    <a:bodyPr/>
                    <a:lstStyle/>
                    <a:p>
                      <a:pPr algn="ctr"/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2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rl_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rl_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rl</a:t>
                      </a:r>
                    </a:p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_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_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</a:t>
                      </a:r>
                    </a:p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ld Chang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</a:p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rrec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ighted differenc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63983190"/>
                  </a:ext>
                </a:extLst>
              </a:tr>
              <a:tr h="231030">
                <a:tc>
                  <a:txBody>
                    <a:bodyPr/>
                    <a:lstStyle/>
                    <a:p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CC-195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6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6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6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7.790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E-10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3E-1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146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436526"/>
                  </a:ext>
                </a:extLst>
              </a:tr>
              <a:tr h="231030">
                <a:tc>
                  <a:txBody>
                    <a:bodyPr/>
                    <a:lstStyle/>
                    <a:p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A-MB-23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3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9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7.44790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3E-1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29E-0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.42E-0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51251755"/>
                  </a:ext>
                </a:extLst>
              </a:tr>
              <a:tr h="230871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C0642_5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9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7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36.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9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7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34.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031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0011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3581917"/>
                  </a:ext>
                </a:extLst>
              </a:tr>
              <a:tr h="305149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C0642_10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9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7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36.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5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8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19.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3854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9.31E-0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7643361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514033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6</TotalTime>
  <Words>157</Words>
  <Application>Microsoft Office PowerPoint</Application>
  <PresentationFormat>Widescreen</PresentationFormat>
  <Paragraphs>8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asvinder Singh</dc:creator>
  <cp:lastModifiedBy>Suppressed entry</cp:lastModifiedBy>
  <cp:revision>5</cp:revision>
  <dcterms:created xsi:type="dcterms:W3CDTF">2024-07-24T14:11:55Z</dcterms:created>
  <dcterms:modified xsi:type="dcterms:W3CDTF">2025-02-23T02:14:19Z</dcterms:modified>
</cp:coreProperties>
</file>